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F30386A-74A1-4FCD-BB80-B9F90A56446C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5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fr-FR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2" name="Espace réservé du numéro de diapositive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B733CFE-CF74-49AB-B75B-5606D56CABD5}" type="slidenum">
              <a:rPr b="0" lang="fr-FR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E853CB-AE5A-4CFC-BE97-2EF67820F0A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B27B9F-C460-4D9A-A44D-E55681592A1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7AB5DF-BD8B-4672-A5E4-FD4177D052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06D703-A57A-4F0C-AC74-26165A60681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B3D078-3956-40C1-B29E-11D23156A5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017FDF-87F1-4FE1-8948-85E224DB807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306A40-CC98-47A7-BD62-F8ABEAE1722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4F9247-E5F0-4B49-9415-BB32D1F312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4C58BF-9441-4C40-8C09-4C793CE8C20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E5104F-4ED0-4733-8BF9-77A7EE03E9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9BA0C1-530D-43CB-AF6F-F7E40E8CA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949DEA-E5F3-4099-AB7F-24A9F8250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C160E5-3C2B-44C2-A4C4-E7F4EA0C1F9D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e 81"/>
          <p:cNvGrpSpPr/>
          <p:nvPr/>
        </p:nvGrpSpPr>
        <p:grpSpPr>
          <a:xfrm>
            <a:off x="142920" y="754560"/>
            <a:ext cx="6357960" cy="3378960"/>
            <a:chOff x="142920" y="754560"/>
            <a:chExt cx="6357960" cy="3378960"/>
          </a:xfrm>
        </p:grpSpPr>
        <p:sp>
          <p:nvSpPr>
            <p:cNvPr id="49" name="Text Box 8"/>
            <p:cNvSpPr/>
            <p:nvPr/>
          </p:nvSpPr>
          <p:spPr>
            <a:xfrm>
              <a:off x="1265760" y="3704760"/>
              <a:ext cx="86364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ICEMmc-1a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(30.13 k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Text Box 9"/>
            <p:cNvSpPr/>
            <p:nvPr/>
          </p:nvSpPr>
          <p:spPr>
            <a:xfrm>
              <a:off x="4649040" y="3704760"/>
              <a:ext cx="86940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ICEMmc-1b 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(28.96 kbp)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Connecteur droit 84"/>
            <p:cNvSpPr/>
            <p:nvPr/>
          </p:nvSpPr>
          <p:spPr>
            <a:xfrm flipH="1">
              <a:off x="2857680" y="2392200"/>
              <a:ext cx="241200" cy="109008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Connecteur droit 85"/>
            <p:cNvSpPr/>
            <p:nvPr/>
          </p:nvSpPr>
          <p:spPr>
            <a:xfrm>
              <a:off x="3091680" y="2373120"/>
              <a:ext cx="671400" cy="110448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Connecteur droit 86"/>
            <p:cNvSpPr/>
            <p:nvPr/>
          </p:nvSpPr>
          <p:spPr>
            <a:xfrm>
              <a:off x="3540960" y="2392200"/>
              <a:ext cx="98280" cy="106956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Connecteur droit 87"/>
            <p:cNvSpPr/>
            <p:nvPr/>
          </p:nvSpPr>
          <p:spPr>
            <a:xfrm flipH="1">
              <a:off x="2950920" y="2400120"/>
              <a:ext cx="563400" cy="1068120"/>
            </a:xfrm>
            <a:prstGeom prst="line">
              <a:avLst/>
            </a:prstGeom>
            <a:ln w="1260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Connecteur droit 88"/>
            <p:cNvSpPr/>
            <p:nvPr/>
          </p:nvSpPr>
          <p:spPr>
            <a:xfrm>
              <a:off x="142920" y="3477600"/>
              <a:ext cx="30988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AutoShape 5"/>
            <p:cNvSpPr/>
            <p:nvPr/>
          </p:nvSpPr>
          <p:spPr>
            <a:xfrm>
              <a:off x="442800" y="3391920"/>
              <a:ext cx="63360" cy="179280"/>
            </a:xfrm>
            <a:custGeom>
              <a:avLst/>
              <a:gdLst>
                <a:gd name="textAreaLeft" fmla="*/ 0 w 63360"/>
                <a:gd name="textAreaRight" fmla="*/ 63720 w 6336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4598" y="0"/>
                  </a:lnTo>
                  <a:lnTo>
                    <a:pt x="21600" y="10800"/>
                  </a:lnTo>
                  <a:lnTo>
                    <a:pt x="14598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AutoShape 14"/>
            <p:cNvSpPr/>
            <p:nvPr/>
          </p:nvSpPr>
          <p:spPr>
            <a:xfrm>
              <a:off x="539640" y="3391920"/>
              <a:ext cx="101520" cy="17928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444" y="0"/>
                  </a:lnTo>
                  <a:lnTo>
                    <a:pt x="21600" y="10800"/>
                  </a:lnTo>
                  <a:lnTo>
                    <a:pt x="1044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AutoShape 18"/>
            <p:cNvSpPr/>
            <p:nvPr/>
          </p:nvSpPr>
          <p:spPr>
            <a:xfrm>
              <a:off x="699840" y="3391920"/>
              <a:ext cx="34920" cy="17928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AutoShape 20"/>
            <p:cNvSpPr/>
            <p:nvPr/>
          </p:nvSpPr>
          <p:spPr>
            <a:xfrm>
              <a:off x="804600" y="3391920"/>
              <a:ext cx="161640" cy="179280"/>
            </a:xfrm>
            <a:custGeom>
              <a:avLst/>
              <a:gdLst>
                <a:gd name="textAreaLeft" fmla="*/ 0 w 161640"/>
                <a:gd name="textAreaRight" fmla="*/ 162000 w 1616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1294" y="0"/>
                  </a:lnTo>
                  <a:lnTo>
                    <a:pt x="21600" y="10800"/>
                  </a:lnTo>
                  <a:lnTo>
                    <a:pt x="1129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AutoShape 21"/>
            <p:cNvSpPr/>
            <p:nvPr/>
          </p:nvSpPr>
          <p:spPr>
            <a:xfrm>
              <a:off x="973080" y="3391920"/>
              <a:ext cx="60120" cy="17928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132" y="0"/>
                  </a:lnTo>
                  <a:lnTo>
                    <a:pt x="21600" y="10800"/>
                  </a:lnTo>
                  <a:lnTo>
                    <a:pt x="15132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AutoShape 22"/>
            <p:cNvSpPr/>
            <p:nvPr/>
          </p:nvSpPr>
          <p:spPr>
            <a:xfrm>
              <a:off x="1047600" y="3391920"/>
              <a:ext cx="33120" cy="179280"/>
            </a:xfrm>
            <a:custGeom>
              <a:avLst/>
              <a:gdLst>
                <a:gd name="textAreaLeft" fmla="*/ 0 w 33120"/>
                <a:gd name="textAreaRight" fmla="*/ 33480 w 331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AutoShape 23"/>
            <p:cNvSpPr/>
            <p:nvPr/>
          </p:nvSpPr>
          <p:spPr>
            <a:xfrm>
              <a:off x="1096920" y="3391920"/>
              <a:ext cx="96840" cy="17928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859" y="0"/>
                  </a:lnTo>
                  <a:lnTo>
                    <a:pt x="21600" y="10800"/>
                  </a:lnTo>
                  <a:lnTo>
                    <a:pt x="1085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AutoShape 25"/>
            <p:cNvSpPr/>
            <p:nvPr/>
          </p:nvSpPr>
          <p:spPr>
            <a:xfrm>
              <a:off x="1220760" y="3391920"/>
              <a:ext cx="147600" cy="179280"/>
            </a:xfrm>
            <a:custGeom>
              <a:avLst/>
              <a:gdLst>
                <a:gd name="textAreaLeft" fmla="*/ 0 w 147600"/>
                <a:gd name="textAreaRight" fmla="*/ 147960 w 14760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2236" y="0"/>
                  </a:lnTo>
                  <a:lnTo>
                    <a:pt x="21600" y="10800"/>
                  </a:lnTo>
                  <a:lnTo>
                    <a:pt x="12236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AutoShape 26"/>
            <p:cNvSpPr/>
            <p:nvPr/>
          </p:nvSpPr>
          <p:spPr>
            <a:xfrm>
              <a:off x="1573200" y="3391920"/>
              <a:ext cx="31680" cy="17928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AutoShape 27"/>
            <p:cNvSpPr/>
            <p:nvPr/>
          </p:nvSpPr>
          <p:spPr>
            <a:xfrm>
              <a:off x="1604880" y="3391920"/>
              <a:ext cx="153720" cy="17928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1485" y="0"/>
                  </a:lnTo>
                  <a:lnTo>
                    <a:pt x="21600" y="10800"/>
                  </a:lnTo>
                  <a:lnTo>
                    <a:pt x="11485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AutoShape 28"/>
            <p:cNvSpPr/>
            <p:nvPr/>
          </p:nvSpPr>
          <p:spPr>
            <a:xfrm>
              <a:off x="1771560" y="3391920"/>
              <a:ext cx="233280" cy="179280"/>
            </a:xfrm>
            <a:custGeom>
              <a:avLst/>
              <a:gdLst>
                <a:gd name="textAreaLeft" fmla="*/ 0 w 233280"/>
                <a:gd name="textAreaRight" fmla="*/ 233640 w 23328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49" y="0"/>
                  </a:lnTo>
                  <a:lnTo>
                    <a:pt x="21600" y="10800"/>
                  </a:lnTo>
                  <a:lnTo>
                    <a:pt x="1564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AutoShape 29"/>
            <p:cNvSpPr/>
            <p:nvPr/>
          </p:nvSpPr>
          <p:spPr>
            <a:xfrm>
              <a:off x="2012760" y="3391920"/>
              <a:ext cx="53640" cy="179280"/>
            </a:xfrm>
            <a:custGeom>
              <a:avLst/>
              <a:gdLst>
                <a:gd name="textAreaLeft" fmla="*/ 0 w 53640"/>
                <a:gd name="textAreaRight" fmla="*/ 54000 w 536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666" y="0"/>
                  </a:lnTo>
                  <a:lnTo>
                    <a:pt x="21600" y="10800"/>
                  </a:lnTo>
                  <a:lnTo>
                    <a:pt x="15666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AutoShape 30"/>
            <p:cNvSpPr/>
            <p:nvPr/>
          </p:nvSpPr>
          <p:spPr>
            <a:xfrm>
              <a:off x="2062080" y="3391920"/>
              <a:ext cx="406080" cy="179280"/>
            </a:xfrm>
            <a:custGeom>
              <a:avLst/>
              <a:gdLst>
                <a:gd name="textAreaLeft" fmla="*/ 0 w 406080"/>
                <a:gd name="textAreaRight" fmla="*/ 406440 w 40608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7436" y="0"/>
                  </a:lnTo>
                  <a:lnTo>
                    <a:pt x="21600" y="10800"/>
                  </a:lnTo>
                  <a:lnTo>
                    <a:pt x="17436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AutoShape 31"/>
            <p:cNvSpPr/>
            <p:nvPr/>
          </p:nvSpPr>
          <p:spPr>
            <a:xfrm>
              <a:off x="2465280" y="3391920"/>
              <a:ext cx="75960" cy="17928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233" y="0"/>
                  </a:lnTo>
                  <a:lnTo>
                    <a:pt x="21600" y="10800"/>
                  </a:lnTo>
                  <a:lnTo>
                    <a:pt x="1323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AutoShape 32"/>
            <p:cNvSpPr/>
            <p:nvPr/>
          </p:nvSpPr>
          <p:spPr>
            <a:xfrm>
              <a:off x="2562120" y="3391920"/>
              <a:ext cx="48960" cy="179280"/>
            </a:xfrm>
            <a:custGeom>
              <a:avLst/>
              <a:gdLst>
                <a:gd name="textAreaLeft" fmla="*/ 0 w 48960"/>
                <a:gd name="textAreaRight" fmla="*/ 49320 w 4896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AutoShape 33"/>
            <p:cNvSpPr/>
            <p:nvPr/>
          </p:nvSpPr>
          <p:spPr>
            <a:xfrm>
              <a:off x="2637000" y="3391920"/>
              <a:ext cx="28440" cy="17928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AutoShape 34"/>
            <p:cNvSpPr/>
            <p:nvPr/>
          </p:nvSpPr>
          <p:spPr>
            <a:xfrm>
              <a:off x="2685960" y="3391920"/>
              <a:ext cx="71280" cy="17928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530" y="0"/>
                  </a:lnTo>
                  <a:lnTo>
                    <a:pt x="21600" y="10800"/>
                  </a:lnTo>
                  <a:lnTo>
                    <a:pt x="1353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AutoShape 35"/>
            <p:cNvSpPr/>
            <p:nvPr/>
          </p:nvSpPr>
          <p:spPr>
            <a:xfrm>
              <a:off x="2757600" y="3391920"/>
              <a:ext cx="99720" cy="17928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563" y="0"/>
                  </a:lnTo>
                  <a:lnTo>
                    <a:pt x="21600" y="10800"/>
                  </a:lnTo>
                  <a:lnTo>
                    <a:pt x="1056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117"/>
            <p:cNvSpPr/>
            <p:nvPr/>
          </p:nvSpPr>
          <p:spPr>
            <a:xfrm>
              <a:off x="637920" y="3391920"/>
              <a:ext cx="47520" cy="17928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AutoShape 131"/>
            <p:cNvSpPr/>
            <p:nvPr/>
          </p:nvSpPr>
          <p:spPr>
            <a:xfrm>
              <a:off x="744480" y="3391920"/>
              <a:ext cx="39600" cy="17928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AutoShape 179"/>
            <p:cNvSpPr/>
            <p:nvPr/>
          </p:nvSpPr>
          <p:spPr>
            <a:xfrm>
              <a:off x="1392120" y="3391920"/>
              <a:ext cx="171360" cy="179280"/>
            </a:xfrm>
            <a:custGeom>
              <a:avLst/>
              <a:gdLst>
                <a:gd name="textAreaLeft" fmla="*/ 0 w 171360"/>
                <a:gd name="textAreaRight" fmla="*/ 171720 w 171360"/>
                <a:gd name="textAreaTop" fmla="*/ 0 h 179280"/>
                <a:gd name="textAreaBottom" fmla="*/ 179640 h 17928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2981" y="0"/>
                  </a:lnTo>
                  <a:lnTo>
                    <a:pt x="21600" y="10800"/>
                  </a:lnTo>
                  <a:lnTo>
                    <a:pt x="12981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Connecteur droit 110"/>
            <p:cNvSpPr/>
            <p:nvPr/>
          </p:nvSpPr>
          <p:spPr>
            <a:xfrm>
              <a:off x="3328920" y="3477600"/>
              <a:ext cx="317196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AutoShape 6"/>
            <p:cNvSpPr/>
            <p:nvPr/>
          </p:nvSpPr>
          <p:spPr>
            <a:xfrm rot="10800000">
              <a:off x="6140160" y="3395160"/>
              <a:ext cx="66600" cy="16632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4598" y="0"/>
                  </a:lnTo>
                  <a:lnTo>
                    <a:pt x="21600" y="10800"/>
                  </a:lnTo>
                  <a:lnTo>
                    <a:pt x="14598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AutoShape 15"/>
            <p:cNvSpPr/>
            <p:nvPr/>
          </p:nvSpPr>
          <p:spPr>
            <a:xfrm rot="10800000">
              <a:off x="6002280" y="3391560"/>
              <a:ext cx="106200" cy="16812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168120"/>
                <a:gd name="textAreaBottom" fmla="*/ 168480 h 1681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444" y="0"/>
                  </a:lnTo>
                  <a:lnTo>
                    <a:pt x="21600" y="10800"/>
                  </a:lnTo>
                  <a:lnTo>
                    <a:pt x="10444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AutoShape 41"/>
            <p:cNvSpPr/>
            <p:nvPr/>
          </p:nvSpPr>
          <p:spPr>
            <a:xfrm rot="10800000">
              <a:off x="5927400" y="3395160"/>
              <a:ext cx="52200" cy="16632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903" y="0"/>
                  </a:lnTo>
                  <a:lnTo>
                    <a:pt x="21600" y="10800"/>
                  </a:lnTo>
                  <a:lnTo>
                    <a:pt x="1590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AutoShape 42"/>
            <p:cNvSpPr/>
            <p:nvPr/>
          </p:nvSpPr>
          <p:spPr>
            <a:xfrm rot="10800000">
              <a:off x="5735880" y="3395160"/>
              <a:ext cx="171360" cy="166320"/>
            </a:xfrm>
            <a:custGeom>
              <a:avLst/>
              <a:gdLst>
                <a:gd name="textAreaLeft" fmla="*/ 0 w 171360"/>
                <a:gd name="textAreaRight" fmla="*/ 171720 w 1713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279" y="0"/>
                  </a:lnTo>
                  <a:lnTo>
                    <a:pt x="21600" y="10800"/>
                  </a:lnTo>
                  <a:lnTo>
                    <a:pt x="1527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AutoShape 43"/>
            <p:cNvSpPr/>
            <p:nvPr/>
          </p:nvSpPr>
          <p:spPr>
            <a:xfrm rot="10800000">
              <a:off x="5667120" y="3395160"/>
              <a:ext cx="61560" cy="16632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5132" y="0"/>
                  </a:lnTo>
                  <a:lnTo>
                    <a:pt x="21600" y="10800"/>
                  </a:lnTo>
                  <a:lnTo>
                    <a:pt x="15132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AutoShape 44"/>
            <p:cNvSpPr/>
            <p:nvPr/>
          </p:nvSpPr>
          <p:spPr>
            <a:xfrm rot="10800000">
              <a:off x="5616360" y="3395160"/>
              <a:ext cx="34920" cy="166320"/>
            </a:xfrm>
            <a:custGeom>
              <a:avLst/>
              <a:gdLst>
                <a:gd name="textAreaLeft" fmla="*/ 0 w 34920"/>
                <a:gd name="textAreaRight" fmla="*/ 35280 w 3492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AutoShape 45"/>
            <p:cNvSpPr/>
            <p:nvPr/>
          </p:nvSpPr>
          <p:spPr>
            <a:xfrm rot="10800000">
              <a:off x="5499360" y="3395160"/>
              <a:ext cx="101520" cy="166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859" y="0"/>
                  </a:lnTo>
                  <a:lnTo>
                    <a:pt x="21600" y="10800"/>
                  </a:lnTo>
                  <a:lnTo>
                    <a:pt x="1085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AutoShape 47"/>
            <p:cNvSpPr/>
            <p:nvPr/>
          </p:nvSpPr>
          <p:spPr>
            <a:xfrm rot="10800000">
              <a:off x="5316840" y="3395160"/>
              <a:ext cx="155520" cy="166320"/>
            </a:xfrm>
            <a:custGeom>
              <a:avLst/>
              <a:gdLst>
                <a:gd name="textAreaLeft" fmla="*/ 0 w 155520"/>
                <a:gd name="textAreaRight" fmla="*/ 155520 w 15552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300" y="0"/>
                  </a:lnTo>
                  <a:lnTo>
                    <a:pt x="21600" y="10800"/>
                  </a:lnTo>
                  <a:lnTo>
                    <a:pt x="133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AutoShape 48"/>
            <p:cNvSpPr/>
            <p:nvPr/>
          </p:nvSpPr>
          <p:spPr>
            <a:xfrm rot="10800000">
              <a:off x="5077080" y="3395160"/>
              <a:ext cx="31680" cy="166320"/>
            </a:xfrm>
            <a:custGeom>
              <a:avLst/>
              <a:gdLst>
                <a:gd name="textAreaLeft" fmla="*/ 0 w 31680"/>
                <a:gd name="textAreaRight" fmla="*/ 32040 w 3168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AutoShape 49"/>
            <p:cNvSpPr/>
            <p:nvPr/>
          </p:nvSpPr>
          <p:spPr>
            <a:xfrm rot="10800000">
              <a:off x="4913640" y="3395160"/>
              <a:ext cx="163440" cy="166320"/>
            </a:xfrm>
            <a:custGeom>
              <a:avLst/>
              <a:gdLst>
                <a:gd name="textAreaLeft" fmla="*/ 0 w 163440"/>
                <a:gd name="textAreaRight" fmla="*/ 163800 w 16344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179" y="0"/>
                  </a:lnTo>
                  <a:lnTo>
                    <a:pt x="21600" y="10800"/>
                  </a:lnTo>
                  <a:lnTo>
                    <a:pt x="13179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AutoShape 50"/>
            <p:cNvSpPr/>
            <p:nvPr/>
          </p:nvSpPr>
          <p:spPr>
            <a:xfrm rot="10800000">
              <a:off x="4656240" y="3395160"/>
              <a:ext cx="242640" cy="166320"/>
            </a:xfrm>
            <a:custGeom>
              <a:avLst/>
              <a:gdLst>
                <a:gd name="textAreaLeft" fmla="*/ 0 w 242640"/>
                <a:gd name="textAreaRight" fmla="*/ 243000 w 24264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466" y="0"/>
                  </a:lnTo>
                  <a:lnTo>
                    <a:pt x="21600" y="10800"/>
                  </a:lnTo>
                  <a:lnTo>
                    <a:pt x="16466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AutoShape 51"/>
            <p:cNvSpPr/>
            <p:nvPr/>
          </p:nvSpPr>
          <p:spPr>
            <a:xfrm rot="10800000">
              <a:off x="4592520" y="3395160"/>
              <a:ext cx="50760" cy="1663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AutoShape 52"/>
            <p:cNvSpPr/>
            <p:nvPr/>
          </p:nvSpPr>
          <p:spPr>
            <a:xfrm rot="10800000">
              <a:off x="4170240" y="3395160"/>
              <a:ext cx="422280" cy="166320"/>
            </a:xfrm>
            <a:custGeom>
              <a:avLst/>
              <a:gdLst>
                <a:gd name="textAreaLeft" fmla="*/ 0 w 422280"/>
                <a:gd name="textAreaRight" fmla="*/ 422640 w 42228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7481" y="0"/>
                  </a:lnTo>
                  <a:lnTo>
                    <a:pt x="21600" y="10800"/>
                  </a:lnTo>
                  <a:lnTo>
                    <a:pt x="17481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AutoShape 53"/>
            <p:cNvSpPr/>
            <p:nvPr/>
          </p:nvSpPr>
          <p:spPr>
            <a:xfrm rot="10800000">
              <a:off x="4092840" y="3395160"/>
              <a:ext cx="80640" cy="166320"/>
            </a:xfrm>
            <a:custGeom>
              <a:avLst/>
              <a:gdLst>
                <a:gd name="textAreaLeft" fmla="*/ 0 w 80640"/>
                <a:gd name="textAreaRight" fmla="*/ 81000 w 8064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233" y="0"/>
                  </a:lnTo>
                  <a:lnTo>
                    <a:pt x="21600" y="10800"/>
                  </a:lnTo>
                  <a:lnTo>
                    <a:pt x="1323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AutoShape 54"/>
            <p:cNvSpPr/>
            <p:nvPr/>
          </p:nvSpPr>
          <p:spPr>
            <a:xfrm rot="10800000">
              <a:off x="4020840" y="3395160"/>
              <a:ext cx="50760" cy="1663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AutoShape 55"/>
            <p:cNvSpPr/>
            <p:nvPr/>
          </p:nvSpPr>
          <p:spPr>
            <a:xfrm rot="10800000">
              <a:off x="3965400" y="3395160"/>
              <a:ext cx="28440" cy="16632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6200" y="0"/>
                  </a:lnTo>
                  <a:lnTo>
                    <a:pt x="21600" y="10800"/>
                  </a:lnTo>
                  <a:lnTo>
                    <a:pt x="1620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AutoShape 56"/>
            <p:cNvSpPr/>
            <p:nvPr/>
          </p:nvSpPr>
          <p:spPr>
            <a:xfrm rot="10800000">
              <a:off x="3866760" y="3395160"/>
              <a:ext cx="75960" cy="16632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3530" y="0"/>
                  </a:lnTo>
                  <a:lnTo>
                    <a:pt x="21600" y="10800"/>
                  </a:lnTo>
                  <a:lnTo>
                    <a:pt x="13530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AutoShape 57"/>
            <p:cNvSpPr/>
            <p:nvPr/>
          </p:nvSpPr>
          <p:spPr>
            <a:xfrm rot="10800000">
              <a:off x="3764160" y="3395160"/>
              <a:ext cx="102960" cy="166320"/>
            </a:xfrm>
            <a:custGeom>
              <a:avLst/>
              <a:gdLst>
                <a:gd name="textAreaLeft" fmla="*/ 0 w 102960"/>
                <a:gd name="textAreaRight" fmla="*/ 103320 w 10296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0563" y="0"/>
                  </a:lnTo>
                  <a:lnTo>
                    <a:pt x="21600" y="10800"/>
                  </a:lnTo>
                  <a:lnTo>
                    <a:pt x="10563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AutoShape 180"/>
            <p:cNvSpPr/>
            <p:nvPr/>
          </p:nvSpPr>
          <p:spPr>
            <a:xfrm rot="10800000">
              <a:off x="5113440" y="3395160"/>
              <a:ext cx="179280" cy="166320"/>
            </a:xfrm>
            <a:custGeom>
              <a:avLst/>
              <a:gdLst>
                <a:gd name="textAreaLeft" fmla="*/ 0 w 179280"/>
                <a:gd name="textAreaRight" fmla="*/ 179640 w 179280"/>
                <a:gd name="textAreaTop" fmla="*/ 0 h 166320"/>
                <a:gd name="textAreaBottom" fmla="*/ 166680 h 166320"/>
              </a:gdLst>
              <a:ahLst/>
              <a:rect l="textAreaLeft" t="textAreaTop" r="textAreaRight" b="textAreaBottom"/>
              <a:pathLst>
                <a:path w="21600" h="21600">
                  <a:moveTo>
                    <a:pt x="0" y="0"/>
                  </a:moveTo>
                  <a:lnTo>
                    <a:pt x="14592" y="0"/>
                  </a:lnTo>
                  <a:lnTo>
                    <a:pt x="21600" y="10800"/>
                  </a:lnTo>
                  <a:lnTo>
                    <a:pt x="14592" y="21600"/>
                  </a:lnTo>
                  <a:lnTo>
                    <a:pt x="0" y="21600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4f81bd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Connecteur droit 130"/>
            <p:cNvSpPr/>
            <p:nvPr/>
          </p:nvSpPr>
          <p:spPr>
            <a:xfrm flipH="1">
              <a:off x="3181320" y="3380760"/>
              <a:ext cx="147600" cy="190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Connecteur droit 131"/>
            <p:cNvSpPr/>
            <p:nvPr/>
          </p:nvSpPr>
          <p:spPr>
            <a:xfrm flipH="1">
              <a:off x="3254040" y="3380760"/>
              <a:ext cx="145800" cy="19044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riangle isocèle 132"/>
            <p:cNvSpPr/>
            <p:nvPr/>
          </p:nvSpPr>
          <p:spPr>
            <a:xfrm rot="5400000">
              <a:off x="287640" y="3441600"/>
              <a:ext cx="96480" cy="60120"/>
            </a:xfrm>
            <a:prstGeom prst="triangle">
              <a:avLst>
                <a:gd name="adj" fmla="val 50338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riangle isocèle 133"/>
            <p:cNvSpPr/>
            <p:nvPr/>
          </p:nvSpPr>
          <p:spPr>
            <a:xfrm rot="16200000">
              <a:off x="2977200" y="3441600"/>
              <a:ext cx="96480" cy="60120"/>
            </a:xfrm>
            <a:prstGeom prst="triangle">
              <a:avLst>
                <a:gd name="adj" fmla="val 50338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riangle isocèle 134"/>
            <p:cNvSpPr/>
            <p:nvPr/>
          </p:nvSpPr>
          <p:spPr>
            <a:xfrm rot="16200000">
              <a:off x="6273720" y="3440880"/>
              <a:ext cx="96480" cy="61560"/>
            </a:xfrm>
            <a:prstGeom prst="triangle">
              <a:avLst>
                <a:gd name="adj" fmla="val 50338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280" bIns="-2628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Bouée 135"/>
            <p:cNvSpPr/>
            <p:nvPr/>
          </p:nvSpPr>
          <p:spPr>
            <a:xfrm>
              <a:off x="2654280" y="1139760"/>
              <a:ext cx="1288800" cy="1279080"/>
            </a:xfrm>
            <a:custGeom>
              <a:avLst/>
              <a:gdLst/>
              <a:ahLst/>
              <a:rect l="l" t="t" r="r" b="b"/>
              <a:pathLst>
                <a:path w="1474949" h="1376127">
                  <a:moveTo>
                    <a:pt x="0" y="688064"/>
                  </a:moveTo>
                  <a:cubicBezTo>
                    <a:pt x="0" y="308057"/>
                    <a:pt x="330179" y="0"/>
                    <a:pt x="737475" y="0"/>
                  </a:cubicBezTo>
                  <a:cubicBezTo>
                    <a:pt x="1144771" y="0"/>
                    <a:pt x="1474950" y="308057"/>
                    <a:pt x="1474950" y="688064"/>
                  </a:cubicBezTo>
                  <a:cubicBezTo>
                    <a:pt x="1474950" y="1068071"/>
                    <a:pt x="1144771" y="1376128"/>
                    <a:pt x="737475" y="1376128"/>
                  </a:cubicBezTo>
                  <a:cubicBezTo>
                    <a:pt x="330179" y="1376128"/>
                    <a:pt x="0" y="1068071"/>
                    <a:pt x="0" y="688064"/>
                  </a:cubicBezTo>
                  <a:close/>
                  <a:moveTo>
                    <a:pt x="77146" y="688064"/>
                  </a:moveTo>
                  <a:cubicBezTo>
                    <a:pt x="77146" y="1025465"/>
                    <a:pt x="372785" y="1298982"/>
                    <a:pt x="737475" y="1298982"/>
                  </a:cubicBezTo>
                  <a:cubicBezTo>
                    <a:pt x="1102165" y="1298982"/>
                    <a:pt x="1397804" y="1025465"/>
                    <a:pt x="1397804" y="688064"/>
                  </a:cubicBezTo>
                  <a:cubicBezTo>
                    <a:pt x="1397804" y="350663"/>
                    <a:pt x="1102165" y="77146"/>
                    <a:pt x="737475" y="77146"/>
                  </a:cubicBezTo>
                  <a:cubicBezTo>
                    <a:pt x="372785" y="77146"/>
                    <a:pt x="77146" y="350663"/>
                    <a:pt x="77146" y="688064"/>
                  </a:cubicBez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1f497d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lèche en arc 136"/>
            <p:cNvSpPr/>
            <p:nvPr/>
          </p:nvSpPr>
          <p:spPr>
            <a:xfrm rot="2718000">
              <a:off x="2489040" y="1069560"/>
              <a:ext cx="1524960" cy="1528560"/>
            </a:xfrm>
            <a:custGeom>
              <a:avLst/>
              <a:gdLst/>
              <a:ahLst/>
              <a:rect l="l" t="t" r="r" b="b"/>
              <a:pathLst>
                <a:path w="1640766" h="1749231">
                  <a:moveTo>
                    <a:pt x="448141" y="159226"/>
                  </a:moveTo>
                  <a:cubicBezTo>
                    <a:pt x="649082" y="39314"/>
                    <a:pt x="889752" y="22639"/>
                    <a:pt x="1103446" y="113823"/>
                  </a:cubicBezTo>
                  <a:cubicBezTo>
                    <a:pt x="1304335" y="199544"/>
                    <a:pt x="1461944" y="372341"/>
                    <a:pt x="1537247" y="589431"/>
                  </a:cubicBezTo>
                  <a:lnTo>
                    <a:pt x="1591075" y="578353"/>
                  </a:lnTo>
                  <a:lnTo>
                    <a:pt x="1496942" y="735380"/>
                  </a:lnTo>
                  <a:lnTo>
                    <a:pt x="1333234" y="631417"/>
                  </a:lnTo>
                  <a:lnTo>
                    <a:pt x="1386915" y="620369"/>
                  </a:lnTo>
                  <a:cubicBezTo>
                    <a:pt x="1322327" y="449846"/>
                    <a:pt x="1195753" y="316047"/>
                    <a:pt x="1037271" y="250765"/>
                  </a:cubicBezTo>
                  <a:cubicBezTo>
                    <a:pt x="866968" y="180614"/>
                    <a:pt x="676824" y="196537"/>
                    <a:pt x="518382" y="294217"/>
                  </a:cubicBezTo>
                  <a:lnTo>
                    <a:pt x="448141" y="159226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385d8a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lèche en arc 137"/>
            <p:cNvSpPr/>
            <p:nvPr/>
          </p:nvSpPr>
          <p:spPr>
            <a:xfrm rot="16893000">
              <a:off x="2504880" y="1085400"/>
              <a:ext cx="1518840" cy="1500120"/>
            </a:xfrm>
            <a:custGeom>
              <a:avLst/>
              <a:gdLst/>
              <a:ahLst/>
              <a:rect l="l" t="t" r="r" b="b"/>
              <a:pathLst>
                <a:path w="1633938" h="1716536">
                  <a:moveTo>
                    <a:pt x="1375860" y="312921"/>
                  </a:moveTo>
                  <a:cubicBezTo>
                    <a:pt x="1443100" y="389508"/>
                    <a:pt x="1495532" y="479180"/>
                    <a:pt x="1530221" y="576919"/>
                  </a:cubicBezTo>
                  <a:lnTo>
                    <a:pt x="1583665" y="567477"/>
                  </a:lnTo>
                  <a:lnTo>
                    <a:pt x="1493534" y="738734"/>
                  </a:lnTo>
                  <a:lnTo>
                    <a:pt x="1325514" y="613087"/>
                  </a:lnTo>
                  <a:lnTo>
                    <a:pt x="1378701" y="603690"/>
                  </a:lnTo>
                  <a:cubicBezTo>
                    <a:pt x="1351691" y="535751"/>
                    <a:pt x="1314065" y="473206"/>
                    <a:pt x="1267430" y="418725"/>
                  </a:cubicBezTo>
                  <a:lnTo>
                    <a:pt x="1375860" y="312921"/>
                  </a:lnTo>
                  <a:close/>
                </a:path>
              </a:pathLst>
            </a:custGeom>
            <a:solidFill>
              <a:srgbClr val="ffffff"/>
            </a:solidFill>
            <a:ln w="25560">
              <a:solidFill>
                <a:srgbClr val="385d8a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ZoneTexte 138"/>
            <p:cNvSpPr/>
            <p:nvPr/>
          </p:nvSpPr>
          <p:spPr>
            <a:xfrm>
              <a:off x="2817000" y="1585800"/>
              <a:ext cx="945720" cy="428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pMmc-950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100" spc="-1" strike="noStrike">
                  <a:solidFill>
                    <a:srgbClr val="000000"/>
                  </a:solidFill>
                  <a:latin typeface="Calibri"/>
                </a:rPr>
                <a:t>1,840 b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ZoneTexte 139"/>
            <p:cNvSpPr/>
            <p:nvPr/>
          </p:nvSpPr>
          <p:spPr>
            <a:xfrm>
              <a:off x="188640" y="3188520"/>
              <a:ext cx="30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ZoneTexte 140"/>
            <p:cNvSpPr/>
            <p:nvPr/>
          </p:nvSpPr>
          <p:spPr>
            <a:xfrm>
              <a:off x="6182640" y="3180240"/>
              <a:ext cx="30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Arc plein 141"/>
            <p:cNvSpPr/>
            <p:nvPr/>
          </p:nvSpPr>
          <p:spPr>
            <a:xfrm rot="10008000">
              <a:off x="2739240" y="1312920"/>
              <a:ext cx="1158840" cy="1118880"/>
            </a:xfrm>
            <a:custGeom>
              <a:avLst/>
              <a:gdLst/>
              <a:ahLst/>
              <a:rect l="l" t="t" r="r" b="b"/>
              <a:pathLst>
                <a:path w="1326001" h="1203684">
                  <a:moveTo>
                    <a:pt x="536606" y="11038"/>
                  </a:moveTo>
                  <a:cubicBezTo>
                    <a:pt x="713242" y="-20101"/>
                    <a:pt x="896235" y="15269"/>
                    <a:pt x="1043575" y="109028"/>
                  </a:cubicBezTo>
                  <a:lnTo>
                    <a:pt x="979536" y="191954"/>
                  </a:lnTo>
                  <a:cubicBezTo>
                    <a:pt x="856619" y="116678"/>
                    <a:pt x="704998" y="88311"/>
                    <a:pt x="558456" y="113173"/>
                  </a:cubicBezTo>
                  <a:lnTo>
                    <a:pt x="536606" y="11038"/>
                  </a:lnTo>
                  <a:close/>
                </a:path>
              </a:pathLst>
            </a:custGeom>
            <a:solidFill>
              <a:srgbClr val="c00000"/>
            </a:solidFill>
            <a:ln w="25560">
              <a:solidFill>
                <a:srgbClr val="c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142"/>
            <p:cNvSpPr/>
            <p:nvPr/>
          </p:nvSpPr>
          <p:spPr>
            <a:xfrm>
              <a:off x="2890800" y="3441240"/>
              <a:ext cx="39600" cy="66600"/>
            </a:xfrm>
            <a:prstGeom prst="rect">
              <a:avLst/>
            </a:prstGeom>
            <a:solidFill>
              <a:srgbClr val="c00000"/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143"/>
            <p:cNvSpPr/>
            <p:nvPr/>
          </p:nvSpPr>
          <p:spPr>
            <a:xfrm>
              <a:off x="3672000" y="3441240"/>
              <a:ext cx="39600" cy="66600"/>
            </a:xfrm>
            <a:prstGeom prst="rect">
              <a:avLst/>
            </a:prstGeom>
            <a:solidFill>
              <a:srgbClr val="c00000"/>
            </a:solidFill>
            <a:ln w="25560">
              <a:solidFill>
                <a:srgbClr val="c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Triangle isocèle 144"/>
            <p:cNvSpPr/>
            <p:nvPr/>
          </p:nvSpPr>
          <p:spPr>
            <a:xfrm rot="5400000">
              <a:off x="3495240" y="3442680"/>
              <a:ext cx="98280" cy="60120"/>
            </a:xfrm>
            <a:prstGeom prst="triangle">
              <a:avLst>
                <a:gd name="adj" fmla="val 50338"/>
              </a:avLst>
            </a:prstGeom>
            <a:solidFill>
              <a:srgbClr val="000000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6640" bIns="-2664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ZoneTexte 145"/>
            <p:cNvSpPr/>
            <p:nvPr/>
          </p:nvSpPr>
          <p:spPr>
            <a:xfrm>
              <a:off x="3354840" y="3214440"/>
              <a:ext cx="30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ZoneTexte 146"/>
            <p:cNvSpPr/>
            <p:nvPr/>
          </p:nvSpPr>
          <p:spPr>
            <a:xfrm>
              <a:off x="2935800" y="3214440"/>
              <a:ext cx="30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</a:rPr>
                <a:t>I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147"/>
            <p:cNvSpPr/>
            <p:nvPr/>
          </p:nvSpPr>
          <p:spPr>
            <a:xfrm>
              <a:off x="2666160" y="3227760"/>
              <a:ext cx="269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148"/>
            <p:cNvSpPr/>
            <p:nvPr/>
          </p:nvSpPr>
          <p:spPr>
            <a:xfrm>
              <a:off x="3686760" y="3227760"/>
              <a:ext cx="26928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Calibri"/>
                </a:rPr>
                <a:t>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Rectangle 149"/>
            <p:cNvSpPr/>
            <p:nvPr/>
          </p:nvSpPr>
          <p:spPr>
            <a:xfrm rot="4648800">
              <a:off x="3672360" y="1505520"/>
              <a:ext cx="403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1000" spc="-1" strike="noStrike">
                  <a:solidFill>
                    <a:srgbClr val="000000"/>
                  </a:solidFill>
                  <a:latin typeface="Calibri"/>
                </a:rPr>
                <a:t>orf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150"/>
            <p:cNvSpPr/>
            <p:nvPr/>
          </p:nvSpPr>
          <p:spPr>
            <a:xfrm rot="20760000">
              <a:off x="2886120" y="1112400"/>
              <a:ext cx="371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Calibri"/>
                </a:rPr>
                <a:t>orf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8" name="Rectangle 169"/>
          <p:cNvSpPr/>
          <p:nvPr/>
        </p:nvSpPr>
        <p:spPr>
          <a:xfrm>
            <a:off x="1224000" y="5654520"/>
            <a:ext cx="493560" cy="108000"/>
          </a:xfrm>
          <a:prstGeom prst="rect">
            <a:avLst/>
          </a:prstGeom>
          <a:solidFill>
            <a:srgbClr val="ffff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Rectangle 171"/>
          <p:cNvSpPr/>
          <p:nvPr/>
        </p:nvSpPr>
        <p:spPr>
          <a:xfrm>
            <a:off x="717480" y="5232240"/>
            <a:ext cx="493920" cy="108000"/>
          </a:xfrm>
          <a:prstGeom prst="rect">
            <a:avLst/>
          </a:prstGeom>
          <a:solidFill>
            <a:srgbClr val="ffff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Rectangle 173"/>
          <p:cNvSpPr/>
          <p:nvPr/>
        </p:nvSpPr>
        <p:spPr>
          <a:xfrm>
            <a:off x="4890960" y="6049800"/>
            <a:ext cx="492120" cy="108000"/>
          </a:xfrm>
          <a:prstGeom prst="rect">
            <a:avLst/>
          </a:prstGeom>
          <a:solidFill>
            <a:srgbClr val="ffff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Rectangle 175"/>
          <p:cNvSpPr/>
          <p:nvPr/>
        </p:nvSpPr>
        <p:spPr>
          <a:xfrm>
            <a:off x="1979640" y="5656320"/>
            <a:ext cx="468360" cy="108000"/>
          </a:xfrm>
          <a:prstGeom prst="rect">
            <a:avLst/>
          </a:prstGeom>
          <a:solidFill>
            <a:srgbClr val="66ff33"/>
          </a:solidFill>
          <a:ln w="2556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Rectangle 177"/>
          <p:cNvSpPr/>
          <p:nvPr/>
        </p:nvSpPr>
        <p:spPr>
          <a:xfrm>
            <a:off x="2247840" y="5232240"/>
            <a:ext cx="455760" cy="108000"/>
          </a:xfrm>
          <a:prstGeom prst="rect">
            <a:avLst/>
          </a:prstGeom>
          <a:solidFill>
            <a:srgbClr val="66ff33"/>
          </a:solidFill>
          <a:ln w="2556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Rectangle 179"/>
          <p:cNvSpPr/>
          <p:nvPr/>
        </p:nvSpPr>
        <p:spPr>
          <a:xfrm>
            <a:off x="4071960" y="6477120"/>
            <a:ext cx="468360" cy="108000"/>
          </a:xfrm>
          <a:prstGeom prst="rect">
            <a:avLst/>
          </a:prstGeom>
          <a:solidFill>
            <a:srgbClr val="66ff33"/>
          </a:solidFill>
          <a:ln w="2556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180"/>
          <p:cNvSpPr/>
          <p:nvPr/>
        </p:nvSpPr>
        <p:spPr>
          <a:xfrm>
            <a:off x="3816360" y="5230800"/>
            <a:ext cx="1079640" cy="108000"/>
          </a:xfrm>
          <a:prstGeom prst="rect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Rectangle 181"/>
          <p:cNvSpPr/>
          <p:nvPr/>
        </p:nvSpPr>
        <p:spPr>
          <a:xfrm>
            <a:off x="1357200" y="6049800"/>
            <a:ext cx="1044720" cy="108000"/>
          </a:xfrm>
          <a:prstGeom prst="rect">
            <a:avLst/>
          </a:prstGeom>
          <a:solidFill>
            <a:srgbClr val="ff0000"/>
          </a:solidFill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26" name="Connecteur droit avec flèche 182"/>
          <p:cNvCxnSpPr/>
          <p:nvPr/>
        </p:nvCxnSpPr>
        <p:spPr>
          <a:xfrm>
            <a:off x="1213920" y="5586480"/>
            <a:ext cx="5688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7" name="Connecteur droit avec flèche 183"/>
          <p:cNvCxnSpPr/>
          <p:nvPr/>
        </p:nvCxnSpPr>
        <p:spPr>
          <a:xfrm>
            <a:off x="721800" y="5156280"/>
            <a:ext cx="5688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8" name="Connecteur droit avec flèche 184"/>
          <p:cNvCxnSpPr/>
          <p:nvPr/>
        </p:nvCxnSpPr>
        <p:spPr>
          <a:xfrm>
            <a:off x="3708360" y="5156280"/>
            <a:ext cx="613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29" name="Connecteur droit avec flèche 185"/>
          <p:cNvCxnSpPr/>
          <p:nvPr/>
        </p:nvCxnSpPr>
        <p:spPr>
          <a:xfrm>
            <a:off x="4932000" y="5978520"/>
            <a:ext cx="5688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0" name="Connecteur droit avec flèche 186"/>
          <p:cNvCxnSpPr/>
          <p:nvPr/>
        </p:nvCxnSpPr>
        <p:spPr>
          <a:xfrm>
            <a:off x="4387320" y="5156280"/>
            <a:ext cx="61344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31" name="Connecteur droit avec flèche 187"/>
          <p:cNvCxnSpPr/>
          <p:nvPr/>
        </p:nvCxnSpPr>
        <p:spPr>
          <a:xfrm>
            <a:off x="2214360" y="5156280"/>
            <a:ext cx="49428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32" name="Connecteur droit avec flèche 188"/>
          <p:cNvCxnSpPr/>
          <p:nvPr/>
        </p:nvCxnSpPr>
        <p:spPr>
          <a:xfrm>
            <a:off x="3803760" y="5978520"/>
            <a:ext cx="38016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33" name="Connecteur droit avec flèche 189"/>
          <p:cNvCxnSpPr/>
          <p:nvPr/>
        </p:nvCxnSpPr>
        <p:spPr>
          <a:xfrm>
            <a:off x="4556160" y="5978520"/>
            <a:ext cx="3420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134" name="Rectangle 190"/>
          <p:cNvSpPr/>
          <p:nvPr/>
        </p:nvSpPr>
        <p:spPr>
          <a:xfrm>
            <a:off x="3532320" y="5654520"/>
            <a:ext cx="493560" cy="108000"/>
          </a:xfrm>
          <a:prstGeom prst="rect">
            <a:avLst/>
          </a:prstGeom>
          <a:solidFill>
            <a:srgbClr val="ffff00"/>
          </a:solidFill>
          <a:ln w="25560">
            <a:solidFill>
              <a:srgbClr val="ff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5" name="Connecteur droit avec flèche 191"/>
          <p:cNvCxnSpPr/>
          <p:nvPr/>
        </p:nvCxnSpPr>
        <p:spPr>
          <a:xfrm>
            <a:off x="3535200" y="5586480"/>
            <a:ext cx="5328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136" name="Rectangle 192"/>
          <p:cNvSpPr/>
          <p:nvPr/>
        </p:nvSpPr>
        <p:spPr>
          <a:xfrm>
            <a:off x="4251240" y="5654520"/>
            <a:ext cx="493920" cy="108000"/>
          </a:xfrm>
          <a:prstGeom prst="rect">
            <a:avLst/>
          </a:prstGeom>
          <a:solidFill>
            <a:srgbClr val="66ff33"/>
          </a:solidFill>
          <a:ln w="25560">
            <a:solidFill>
              <a:srgbClr val="66ff3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7" name="Connecteur droit avec flèche 193"/>
          <p:cNvCxnSpPr/>
          <p:nvPr/>
        </p:nvCxnSpPr>
        <p:spPr>
          <a:xfrm>
            <a:off x="4210200" y="5586480"/>
            <a:ext cx="5688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138" name="Rectangle 18"/>
          <p:cNvSpPr/>
          <p:nvPr/>
        </p:nvSpPr>
        <p:spPr>
          <a:xfrm>
            <a:off x="642960" y="5184000"/>
            <a:ext cx="5643720" cy="146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TGTTACAAATTCATAACAGAAGTGTAACAGTTTTGGACTATTCCTATTTACTAAAGTAAATAGTTTTTTAGGTGT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CAGTTTTGTTACACTTTTGTAACAAATTTAACTATAGTGTTACACTTTGTAACAGTTTAAAATGCTTATTTTTT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AGCAAGTACATTTACTAAAGTAAATGTAAAAGATAAGGAAAAGTTGCCCCCGGTTAGGGGGTGTTACAACGCCTTA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endParaRPr b="0" lang="en-US" sz="9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Courier New"/>
                <a:ea typeface="Courier New"/>
              </a:rPr>
              <a:t>TCTTGCCTTTAAAGGATGCGCGCGCACGAGAGAGTAAAAAAACCGAGTTTGTAACAGT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39" name="Connecteur droit avec flèche 195"/>
          <p:cNvCxnSpPr/>
          <p:nvPr/>
        </p:nvCxnSpPr>
        <p:spPr>
          <a:xfrm>
            <a:off x="1932120" y="5584320"/>
            <a:ext cx="5688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40" name="Connecteur droit avec flèche 196"/>
          <p:cNvCxnSpPr/>
          <p:nvPr/>
        </p:nvCxnSpPr>
        <p:spPr>
          <a:xfrm>
            <a:off x="1174680" y="5981760"/>
            <a:ext cx="6829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141" name="Connecteur droit avec flèche 197"/>
          <p:cNvCxnSpPr/>
          <p:nvPr/>
        </p:nvCxnSpPr>
        <p:spPr>
          <a:xfrm>
            <a:off x="1928880" y="5981760"/>
            <a:ext cx="64512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142" name="Connecteur droit avec flèche 198"/>
          <p:cNvCxnSpPr/>
          <p:nvPr/>
        </p:nvCxnSpPr>
        <p:spPr>
          <a:xfrm>
            <a:off x="4000680" y="6370200"/>
            <a:ext cx="53064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143" name="Connecteur droit 199"/>
          <p:cNvSpPr/>
          <p:nvPr/>
        </p:nvSpPr>
        <p:spPr>
          <a:xfrm>
            <a:off x="1214280" y="5799240"/>
            <a:ext cx="4716720" cy="0"/>
          </a:xfrm>
          <a:prstGeom prst="line">
            <a:avLst/>
          </a:prstGeom>
          <a:ln w="93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Connecteur droit 200"/>
          <p:cNvSpPr/>
          <p:nvPr/>
        </p:nvSpPr>
        <p:spPr>
          <a:xfrm>
            <a:off x="755640" y="6191280"/>
            <a:ext cx="4140360" cy="0"/>
          </a:xfrm>
          <a:prstGeom prst="line">
            <a:avLst/>
          </a:prstGeom>
          <a:ln w="9360">
            <a:solidFill>
              <a:srgbClr val="000000"/>
            </a:solidFill>
            <a:prstDash val="sys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ZoneTexte 202"/>
          <p:cNvSpPr/>
          <p:nvPr/>
        </p:nvSpPr>
        <p:spPr>
          <a:xfrm>
            <a:off x="664560" y="6429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ZoneTexte 203"/>
          <p:cNvSpPr/>
          <p:nvPr/>
        </p:nvSpPr>
        <p:spPr>
          <a:xfrm>
            <a:off x="592920" y="4500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Arc plein 212"/>
          <p:cNvSpPr/>
          <p:nvPr/>
        </p:nvSpPr>
        <p:spPr>
          <a:xfrm rot="9395400">
            <a:off x="2980440" y="1630080"/>
            <a:ext cx="660600" cy="658800"/>
          </a:xfrm>
          <a:custGeom>
            <a:avLst/>
            <a:gdLst/>
            <a:ahLst/>
            <a:rect l="l" t="t" r="r" b="b"/>
            <a:pathLst>
              <a:path w="660400" h="658812">
                <a:moveTo>
                  <a:pt x="364761" y="1809"/>
                </a:moveTo>
                <a:cubicBezTo>
                  <a:pt x="432745" y="8947"/>
                  <a:pt x="496833" y="36958"/>
                  <a:pt x="548180" y="81976"/>
                </a:cubicBezTo>
                <a:lnTo>
                  <a:pt x="547653" y="82575"/>
                </a:lnTo>
                <a:cubicBezTo>
                  <a:pt x="496430" y="37666"/>
                  <a:pt x="432497" y="9723"/>
                  <a:pt x="364677" y="2602"/>
                </a:cubicBezTo>
                <a:cubicBezTo>
                  <a:pt x="364705" y="2338"/>
                  <a:pt x="364733" y="2073"/>
                  <a:pt x="364761" y="1809"/>
                </a:cubicBezTo>
                <a:close/>
              </a:path>
            </a:pathLst>
          </a:custGeom>
          <a:solidFill>
            <a:srgbClr val="000000"/>
          </a:solidFill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ZoneTexte 213"/>
          <p:cNvSpPr/>
          <p:nvPr/>
        </p:nvSpPr>
        <p:spPr>
          <a:xfrm>
            <a:off x="3143160" y="2071800"/>
            <a:ext cx="3571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800" spc="-1" strike="noStrike">
                <a:solidFill>
                  <a:srgbClr val="000000"/>
                </a:solidFill>
                <a:latin typeface="Arial"/>
              </a:rPr>
              <a:t>ss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620640" y="7164360"/>
            <a:ext cx="5472360" cy="1312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000" spc="-1" strike="noStrike">
                <a:solidFill>
                  <a:srgbClr val="000000"/>
                </a:solidFill>
                <a:latin typeface="Arial"/>
              </a:rPr>
              <a:t>Legend: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A: Location of the sequence (in red) shared by the plasmid pMmc-95010 and the Mmc chromosome. ICE terminal inverted repeats (IR) are indicated by arrow heads. 22 : ICEMmc CDS22, sso: putative single strand origi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B: Detailed DNA sequence of the pMmc-95010 region aligning with Mmc chromosomal sequences. Inverted repeats are indicated by arrows and direct repeats by identically coloured boxes. pKMK1/pADB201 single strand origin proposed by King et al. [19] is underlined with a dashed line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5-11T14:17:59Z</dcterms:created>
  <dc:creator>pdemol38</dc:creator>
  <dc:description/>
  <dc:language>en-US</dc:language>
  <cp:lastModifiedBy>THIAUCOURT</cp:lastModifiedBy>
  <dcterms:modified xsi:type="dcterms:W3CDTF">2011-02-02T09:55:26Z</dcterms:modified>
  <cp:revision>143</cp:revision>
  <dc:subject/>
  <dc:title>Diapositive 1</dc:title>
</cp:coreProperties>
</file>